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E307A-B347-4FD2-A758-3E8E77F85D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06040-C889-4429-B9D4-16C947E0F7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549CB-6064-4FA3-B06E-4171F6884D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E0004-82C3-4FE8-B7BC-9D5BC65630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83BB6-673C-4BAA-93EE-48CA8AFA88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E1173-D2C0-4F37-9FD4-317AF54DEB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027696-6338-4603-B722-54B8E25C82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2CE96-AC28-44B5-ACE8-2B1FF322A6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EB27E-0AEB-4F90-9774-81AE838F1B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ABB81-9DF8-480B-BE97-15E7AB5804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42996-8187-4539-A673-D08FFCAEAE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3DA53-9FCC-4AA7-8CD0-E944EF2340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963A29-0DA6-4970-BF83-A1BAA64C0C9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08000" y="1282680"/>
            <a:ext cx="8913600" cy="46674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1"/>
          <p:cNvSpPr/>
          <p:nvPr/>
        </p:nvSpPr>
        <p:spPr>
          <a:xfrm>
            <a:off x="124920" y="817920"/>
            <a:ext cx="671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A. PCA plots for MAQC2 gene level brain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295280" y="1638360"/>
          <a:ext cx="2916360" cy="198900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.8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.12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01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48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.73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42E-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.92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72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5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6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279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9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797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Rectangle 4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54000" y="1197000"/>
            <a:ext cx="8910720" cy="502272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1"/>
          <p:cNvSpPr/>
          <p:nvPr/>
        </p:nvSpPr>
        <p:spPr>
          <a:xfrm>
            <a:off x="126720" y="829080"/>
            <a:ext cx="668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B. PCA plots for MAQC2 gene level UHR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1295280" y="1650960"/>
          <a:ext cx="2916360" cy="220968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.8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.96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.8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40E-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.5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80E-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.02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89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28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58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89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1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3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3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86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8" name="Rectangle 8"/>
          <p:cNvSpPr/>
          <p:nvPr/>
        </p:nvSpPr>
        <p:spPr>
          <a:xfrm>
            <a:off x="2268360" y="1281240"/>
            <a:ext cx="3589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193680" y="1268280"/>
            <a:ext cx="8915400" cy="496584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1"/>
          <p:cNvSpPr/>
          <p:nvPr/>
        </p:nvSpPr>
        <p:spPr>
          <a:xfrm>
            <a:off x="119520" y="817920"/>
            <a:ext cx="5837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C. PCA plots for Marioni liver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7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1295280" y="1650960"/>
          <a:ext cx="2916360" cy="220968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8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85E-0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.5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10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7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58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41E-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.13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22E-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9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562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68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449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07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54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4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652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"/>
          <p:cNvPicPr/>
          <p:nvPr/>
        </p:nvPicPr>
        <p:blipFill>
          <a:blip r:embed="rId1"/>
          <a:stretch/>
        </p:blipFill>
        <p:spPr>
          <a:xfrm>
            <a:off x="108000" y="1268280"/>
            <a:ext cx="8913600" cy="4667400"/>
          </a:xfrm>
          <a:prstGeom prst="rect">
            <a:avLst/>
          </a:prstGeom>
          <a:ln w="0">
            <a:noFill/>
          </a:ln>
        </p:spPr>
      </p:pic>
      <p:sp>
        <p:nvSpPr>
          <p:cNvPr id="54" name="Rectangle 1"/>
          <p:cNvSpPr/>
          <p:nvPr/>
        </p:nvSpPr>
        <p:spPr>
          <a:xfrm>
            <a:off x="121320" y="817920"/>
            <a:ext cx="600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D. PCA plots for Marioni kidney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5" name=""/>
          <p:cNvGraphicFramePr/>
          <p:nvPr/>
        </p:nvGraphicFramePr>
        <p:xfrm>
          <a:off x="1295280" y="1638360"/>
          <a:ext cx="2916360" cy="220968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.89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2E-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12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0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8E-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.87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10E-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.04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45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23791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63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48306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52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08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2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0513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6" name="Rectangle 8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122400" y="1341360"/>
            <a:ext cx="8913600" cy="4665600"/>
          </a:xfrm>
          <a:prstGeom prst="rect">
            <a:avLst/>
          </a:prstGeom>
          <a:ln w="0">
            <a:noFill/>
          </a:ln>
        </p:spPr>
      </p:pic>
      <p:sp>
        <p:nvSpPr>
          <p:cNvPr id="58" name="Rectangle 1"/>
          <p:cNvSpPr/>
          <p:nvPr/>
        </p:nvSpPr>
        <p:spPr>
          <a:xfrm>
            <a:off x="110160" y="817920"/>
            <a:ext cx="550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E. PCA plots for FRT-Seq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9" name=""/>
          <p:cNvGraphicFramePr/>
          <p:nvPr/>
        </p:nvGraphicFramePr>
        <p:xfrm>
          <a:off x="1295280" y="1638360"/>
          <a:ext cx="2916360" cy="198900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3.47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.5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55E-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79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242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.28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06E-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57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3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9748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7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24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64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30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0" name="Rectangle 11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"/>
          <p:cNvPicPr/>
          <p:nvPr/>
        </p:nvPicPr>
        <p:blipFill>
          <a:blip r:embed="rId1"/>
          <a:stretch/>
        </p:blipFill>
        <p:spPr>
          <a:xfrm>
            <a:off x="122400" y="1341360"/>
            <a:ext cx="8913600" cy="4665600"/>
          </a:xfrm>
          <a:prstGeom prst="rect">
            <a:avLst/>
          </a:prstGeom>
          <a:ln w="0">
            <a:noFill/>
          </a:ln>
        </p:spPr>
      </p:pic>
      <p:sp>
        <p:nvSpPr>
          <p:cNvPr id="62" name="Rectangle 1"/>
          <p:cNvSpPr/>
          <p:nvPr/>
        </p:nvSpPr>
        <p:spPr>
          <a:xfrm>
            <a:off x="112680" y="817920"/>
            <a:ext cx="568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F. PCA plots for Lee35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3" name=""/>
          <p:cNvGraphicFramePr/>
          <p:nvPr/>
        </p:nvGraphicFramePr>
        <p:xfrm>
          <a:off x="1511280" y="1413000"/>
          <a:ext cx="2916360" cy="265104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.3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42E-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.3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9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.08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.49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01E-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79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243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20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1E-0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4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488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545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8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8751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7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26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4" name="Rectangle 11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" descr=""/>
          <p:cNvPicPr/>
          <p:nvPr/>
        </p:nvPicPr>
        <p:blipFill>
          <a:blip r:embed="rId1"/>
          <a:stretch/>
        </p:blipFill>
        <p:spPr>
          <a:xfrm>
            <a:off x="122400" y="1268280"/>
            <a:ext cx="8913600" cy="466740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1"/>
          <p:cNvSpPr/>
          <p:nvPr/>
        </p:nvSpPr>
        <p:spPr>
          <a:xfrm>
            <a:off x="119520" y="817920"/>
            <a:ext cx="6942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G. PCA plots for Nagalakshmi oligo dT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7" name=""/>
          <p:cNvGraphicFramePr/>
          <p:nvPr/>
        </p:nvGraphicFramePr>
        <p:xfrm>
          <a:off x="1511280" y="1413000"/>
          <a:ext cx="2916360" cy="2651040"/>
        </p:xfrm>
        <a:graphic>
          <a:graphicData uri="http://schemas.openxmlformats.org/drawingml/2006/table">
            <a:tbl>
              <a:tblPr/>
              <a:tblGrid>
                <a:gridCol w="973080"/>
                <a:gridCol w="971640"/>
                <a:gridCol w="97164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49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2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.14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41E-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9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8.34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.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7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7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.37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71E-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6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7027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58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0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8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3E-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38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67217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8" name="Rectangle 8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"/>
          <p:cNvPicPr/>
          <p:nvPr/>
        </p:nvPicPr>
        <p:blipFill>
          <a:blip r:embed="rId1"/>
          <a:stretch/>
        </p:blipFill>
        <p:spPr>
          <a:xfrm>
            <a:off x="108000" y="1273320"/>
            <a:ext cx="8913600" cy="4964040"/>
          </a:xfrm>
          <a:prstGeom prst="rect">
            <a:avLst/>
          </a:prstGeom>
          <a:ln w="0">
            <a:noFill/>
          </a:ln>
        </p:spPr>
      </p:pic>
      <p:sp>
        <p:nvSpPr>
          <p:cNvPr id="70" name="Rectangle 1"/>
          <p:cNvSpPr/>
          <p:nvPr/>
        </p:nvSpPr>
        <p:spPr>
          <a:xfrm>
            <a:off x="101880" y="817920"/>
            <a:ext cx="762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8H. PCA plots for Nagalakshmi random hexamer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1" name=""/>
          <p:cNvGraphicFramePr/>
          <p:nvPr/>
        </p:nvGraphicFramePr>
        <p:xfrm>
          <a:off x="1490760" y="1413000"/>
          <a:ext cx="2916000" cy="2651040"/>
        </p:xfrm>
        <a:graphic>
          <a:graphicData uri="http://schemas.openxmlformats.org/drawingml/2006/table">
            <a:tbl>
              <a:tblPr/>
              <a:tblGrid>
                <a:gridCol w="971280"/>
                <a:gridCol w="971640"/>
                <a:gridCol w="973080"/>
              </a:tblGrid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dict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par 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9419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53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9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.17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23E-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8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.5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2.2e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19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5E-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46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2E-0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9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2018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58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797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11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03E-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6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3332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2" name="Rectangle 8"/>
          <p:cNvSpPr/>
          <p:nvPr/>
        </p:nvSpPr>
        <p:spPr>
          <a:xfrm>
            <a:off x="2124000" y="1268280"/>
            <a:ext cx="36036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27:52Z</dcterms:created>
  <dc:creator>Wei Zheng</dc:creator>
  <dc:description/>
  <dc:language>en-US</dc:language>
  <cp:lastModifiedBy>Wei Zheng</cp:lastModifiedBy>
  <dcterms:modified xsi:type="dcterms:W3CDTF">2011-06-06T17:28:29Z</dcterms:modified>
  <cp:revision>1</cp:revision>
  <dc:subject/>
  <dc:title>Slide 1</dc:title>
</cp:coreProperties>
</file>